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8"/>
  </p:notesMasterIdLst>
  <p:sldIdLst>
    <p:sldId id="271" r:id="rId2"/>
    <p:sldId id="290" r:id="rId3"/>
    <p:sldId id="272" r:id="rId4"/>
    <p:sldId id="285" r:id="rId5"/>
    <p:sldId id="274" r:id="rId6"/>
    <p:sldId id="284" r:id="rId7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9C58523-AAB5-6C79-90DA-43262C017364}" name="Ipsita Pal" initials="IP" userId="S::ip2326@cumc.columbia.edu::2ec8184a-64cf-4e2c-9305-a1ec534bb36d" providerId="AD"/>
  <p188:author id="{C50BD549-CFE1-9A56-8F41-49876D9053E3}" name="Zuberi, Samir (sz9uf)" initials="Z(" userId="S::sz9uf@virginia.edu::9d922603-5e91-402d-a123-e1848e9e70a2" providerId="AD"/>
  <p188:author id="{8FCD438D-6AE6-DF03-7BAB-07808217AFA8}" name="Ipsita" initials="I" userId="S::USU9JC@uvahealth.org::77390b30-4502-4a30-9c14-7d9c397a9197" providerId="AD"/>
  <p188:author id="{1AB90CE9-6400-FCB5-D2DF-EF9322ADC980}" name="Damera, Deepthi Priyanka (kys5tk)" initials="DD" userId="S::kys5tk@virginia.edu::856f7e22-b7f3-484a-8173-3c0e84e41534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92" autoAdjust="0"/>
    <p:restoredTop sz="96208" autoAdjust="0"/>
  </p:normalViewPr>
  <p:slideViewPr>
    <p:cSldViewPr snapToGrid="0">
      <p:cViewPr varScale="1">
        <p:scale>
          <a:sx n="48" d="100"/>
          <a:sy n="48" d="100"/>
        </p:scale>
        <p:origin x="2128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image" Target="../media/image3.emf"/><Relationship Id="rId4" Type="http://schemas.openxmlformats.org/officeDocument/2006/relationships/image" Target="../media/image6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image" Target="../media/image8.emf"/><Relationship Id="rId4" Type="http://schemas.openxmlformats.org/officeDocument/2006/relationships/image" Target="../media/image11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image" Target="../media/image12.emf"/><Relationship Id="rId4" Type="http://schemas.openxmlformats.org/officeDocument/2006/relationships/image" Target="../media/image15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977621E-DB12-4B16-9302-5B2AFA681E57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BD08CD8-B5CA-44AB-8C5A-B28FF17AB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79775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BD08CD8-B5CA-44AB-8C5A-B28FF17AB406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484509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BD08CD8-B5CA-44AB-8C5A-B28FF17AB406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30216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80CAB-0454-4844-BC52-2496F1C451BF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DED98-0CA5-4BBF-8117-F003836F4A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58626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80CAB-0454-4844-BC52-2496F1C451BF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DED98-0CA5-4BBF-8117-F003836F4A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2786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80CAB-0454-4844-BC52-2496F1C451BF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DED98-0CA5-4BBF-8117-F003836F4A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62432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80CAB-0454-4844-BC52-2496F1C451BF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DED98-0CA5-4BBF-8117-F003836F4A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67723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80CAB-0454-4844-BC52-2496F1C451BF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DED98-0CA5-4BBF-8117-F003836F4A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65667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80CAB-0454-4844-BC52-2496F1C451BF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DED98-0CA5-4BBF-8117-F003836F4A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71824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80CAB-0454-4844-BC52-2496F1C451BF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DED98-0CA5-4BBF-8117-F003836F4A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30633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80CAB-0454-4844-BC52-2496F1C451BF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DED98-0CA5-4BBF-8117-F003836F4A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95949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80CAB-0454-4844-BC52-2496F1C451BF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DED98-0CA5-4BBF-8117-F003836F4A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75911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80CAB-0454-4844-BC52-2496F1C451BF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DED98-0CA5-4BBF-8117-F003836F4A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77048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80CAB-0454-4844-BC52-2496F1C451BF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DED98-0CA5-4BBF-8117-F003836F4A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64350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E80CAB-0454-4844-BC52-2496F1C451BF}" type="datetimeFigureOut">
              <a:rPr lang="en-US" smtClean="0"/>
              <a:t>7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0DED98-0CA5-4BBF-8117-F003836F4A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7570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4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6.emf"/><Relationship Id="rId5" Type="http://schemas.openxmlformats.org/officeDocument/2006/relationships/image" Target="../media/image3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5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7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9.bin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9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4.vml"/><Relationship Id="rId6" Type="http://schemas.openxmlformats.org/officeDocument/2006/relationships/oleObject" Target="../embeddings/oleObject8.bin"/><Relationship Id="rId11" Type="http://schemas.openxmlformats.org/officeDocument/2006/relationships/image" Target="../media/image11.emf"/><Relationship Id="rId5" Type="http://schemas.openxmlformats.org/officeDocument/2006/relationships/image" Target="../media/image8.emf"/><Relationship Id="rId10" Type="http://schemas.openxmlformats.org/officeDocument/2006/relationships/oleObject" Target="../embeddings/oleObject10.bin"/><Relationship Id="rId4" Type="http://schemas.openxmlformats.org/officeDocument/2006/relationships/oleObject" Target="../embeddings/oleObject7.bin"/><Relationship Id="rId9" Type="http://schemas.openxmlformats.org/officeDocument/2006/relationships/image" Target="../media/image10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3" Type="http://schemas.openxmlformats.org/officeDocument/2006/relationships/oleObject" Target="../embeddings/oleObject11.bin"/><Relationship Id="rId7" Type="http://schemas.openxmlformats.org/officeDocument/2006/relationships/oleObject" Target="../embeddings/oleObject1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13.emf"/><Relationship Id="rId5" Type="http://schemas.openxmlformats.org/officeDocument/2006/relationships/oleObject" Target="../embeddings/oleObject12.bin"/><Relationship Id="rId10" Type="http://schemas.openxmlformats.org/officeDocument/2006/relationships/image" Target="../media/image15.emf"/><Relationship Id="rId4" Type="http://schemas.openxmlformats.org/officeDocument/2006/relationships/image" Target="../media/image12.emf"/><Relationship Id="rId9" Type="http://schemas.openxmlformats.org/officeDocument/2006/relationships/oleObject" Target="../embeddings/oleObject1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F634F87-BCE4-4C83-A8D2-51DBA821AC4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99" t="56384"/>
          <a:stretch/>
        </p:blipFill>
        <p:spPr bwMode="auto">
          <a:xfrm>
            <a:off x="236797" y="693750"/>
            <a:ext cx="6357434" cy="2236211"/>
          </a:xfrm>
          <a:prstGeom prst="rect">
            <a:avLst/>
          </a:prstGeom>
          <a:noFill/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5B3694E-7120-4CA7-AD32-0E67CE34D6BD}"/>
              </a:ext>
            </a:extLst>
          </p:cNvPr>
          <p:cNvSpPr txBox="1"/>
          <p:nvPr/>
        </p:nvSpPr>
        <p:spPr>
          <a:xfrm>
            <a:off x="5500441" y="1"/>
            <a:ext cx="1109599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62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8E4F868-7007-6622-AA6D-2A5664E969D7}"/>
              </a:ext>
            </a:extLst>
          </p:cNvPr>
          <p:cNvSpPr txBox="1"/>
          <p:nvPr/>
        </p:nvSpPr>
        <p:spPr>
          <a:xfrm>
            <a:off x="236798" y="2929961"/>
            <a:ext cx="6357434" cy="6038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108" dirty="0">
                <a:latin typeface="Arial" panose="020B0604020202020204" pitchFamily="34" charset="0"/>
                <a:cs typeface="Arial" panose="020B0604020202020204" pitchFamily="34" charset="0"/>
              </a:rPr>
              <a:t>Figure S1. HH (CTCL), SUP-M2 (ALK+ ALCL) TL1 (LGL-leukemia), NKL (NK cell lymphoblastic leukemia/lymphoma), FM3-29 (melanoma) were treated with different analogs of ghost PNP. The cytotoxicity was determined using </a:t>
            </a:r>
            <a:r>
              <a:rPr lang="en-US" sz="1108" dirty="0" err="1">
                <a:latin typeface="Arial" panose="020B0604020202020204" pitchFamily="34" charset="0"/>
                <a:cs typeface="Arial" panose="020B0604020202020204" pitchFamily="34" charset="0"/>
              </a:rPr>
              <a:t>CellTiter</a:t>
            </a:r>
            <a:r>
              <a:rPr lang="en-US" sz="1108" dirty="0">
                <a:latin typeface="Arial" panose="020B0604020202020204" pitchFamily="34" charset="0"/>
                <a:cs typeface="Arial" panose="020B0604020202020204" pitchFamily="34" charset="0"/>
              </a:rPr>
              <a:t>-Glo assay after 60 hours of treatment. </a:t>
            </a:r>
          </a:p>
        </p:txBody>
      </p:sp>
    </p:spTree>
    <p:extLst>
      <p:ext uri="{BB962C8B-B14F-4D97-AF65-F5344CB8AC3E}">
        <p14:creationId xmlns:p14="http://schemas.microsoft.com/office/powerpoint/2010/main" val="32268621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FFBA524-51F5-70C7-294F-D688CB34C605}"/>
              </a:ext>
            </a:extLst>
          </p:cNvPr>
          <p:cNvSpPr txBox="1"/>
          <p:nvPr/>
        </p:nvSpPr>
        <p:spPr>
          <a:xfrm>
            <a:off x="5500441" y="-2780"/>
            <a:ext cx="1109599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62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773649AE-CF9E-DE04-E5AE-4220CF9926C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96944389"/>
              </p:ext>
            </p:extLst>
          </p:nvPr>
        </p:nvGraphicFramePr>
        <p:xfrm>
          <a:off x="767177" y="338141"/>
          <a:ext cx="3865584" cy="24790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9" r:id="rId3" imgW="5891100" imgH="3778016" progId="Prism9.Document">
                  <p:embed/>
                </p:oleObj>
              </mc:Choice>
              <mc:Fallback>
                <p:oleObj name="Prism 9" r:id="rId3" imgW="5891100" imgH="3778016" progId="Prism9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374C7FBE-35B8-4922-B5EC-860DED739FA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67177" y="338141"/>
                        <a:ext cx="3865584" cy="24790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DFEC182D-D9D6-E8A5-A83E-7499BE7A7B9E}"/>
              </a:ext>
            </a:extLst>
          </p:cNvPr>
          <p:cNvSpPr txBox="1"/>
          <p:nvPr/>
        </p:nvSpPr>
        <p:spPr>
          <a:xfrm>
            <a:off x="472360" y="3207414"/>
            <a:ext cx="6121871" cy="433324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algn="just"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108" dirty="0"/>
              <a:t>Figure S2. IC50 (</a:t>
            </a:r>
            <a:r>
              <a:rPr lang="en-US" sz="1108" dirty="0" err="1"/>
              <a:t>nM</a:t>
            </a:r>
            <a:r>
              <a:rPr lang="en-US" sz="1108" dirty="0"/>
              <a:t>) for romidepsin and  Nanoromidepsin analogs for the 8 cell lines at 48 hours.</a:t>
            </a:r>
          </a:p>
        </p:txBody>
      </p:sp>
    </p:spTree>
    <p:extLst>
      <p:ext uri="{BB962C8B-B14F-4D97-AF65-F5344CB8AC3E}">
        <p14:creationId xmlns:p14="http://schemas.microsoft.com/office/powerpoint/2010/main" val="23723967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25008278"/>
              </p:ext>
            </p:extLst>
          </p:nvPr>
        </p:nvGraphicFramePr>
        <p:xfrm>
          <a:off x="263771" y="1078150"/>
          <a:ext cx="2766646" cy="23416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4" name="Prism 10" r:id="rId4" imgW="4997603" imgH="4227848" progId="Prism10.Document">
                  <p:embed/>
                </p:oleObj>
              </mc:Choice>
              <mc:Fallback>
                <p:oleObj name="Prism 10" r:id="rId4" imgW="4997603" imgH="4227848" progId="Prism10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63771" y="1078150"/>
                        <a:ext cx="2766646" cy="23416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18539473"/>
              </p:ext>
            </p:extLst>
          </p:nvPr>
        </p:nvGraphicFramePr>
        <p:xfrm>
          <a:off x="3311324" y="1078150"/>
          <a:ext cx="3282908" cy="23415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5" name="Prism 10" r:id="rId6" imgW="5927474" imgH="4227848" progId="Prism10.Document">
                  <p:embed/>
                </p:oleObj>
              </mc:Choice>
              <mc:Fallback>
                <p:oleObj name="Prism 10" r:id="rId6" imgW="5927474" imgH="4227848" progId="Prism10.Document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311324" y="1078150"/>
                        <a:ext cx="3282908" cy="23415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57003397"/>
              </p:ext>
            </p:extLst>
          </p:nvPr>
        </p:nvGraphicFramePr>
        <p:xfrm>
          <a:off x="263770" y="3417406"/>
          <a:ext cx="2576146" cy="23416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6" name="Prism 10" r:id="rId8" imgW="4652953" imgH="4227848" progId="Prism10.Document">
                  <p:embed/>
                </p:oleObj>
              </mc:Choice>
              <mc:Fallback>
                <p:oleObj name="Prism 10" r:id="rId8" imgW="4652953" imgH="4227848" progId="Prism10.Document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63770" y="3417406"/>
                        <a:ext cx="2576146" cy="23416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3413216"/>
              </p:ext>
            </p:extLst>
          </p:nvPr>
        </p:nvGraphicFramePr>
        <p:xfrm>
          <a:off x="3311323" y="3417406"/>
          <a:ext cx="3330181" cy="23415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7" name="Prism 10" r:id="rId10" imgW="6012826" imgH="4227848" progId="Prism10.Document">
                  <p:embed/>
                </p:oleObj>
              </mc:Choice>
              <mc:Fallback>
                <p:oleObj name="Prism 10" r:id="rId10" imgW="6012826" imgH="4227848" progId="Prism10.Document">
                  <p:embed/>
                  <p:pic>
                    <p:nvPicPr>
                      <p:cNvPr id="7" name="Object 6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311323" y="3417406"/>
                        <a:ext cx="3330181" cy="23415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CA4ADCA6-D4B3-47B0-9732-3C476A9A6911}"/>
              </a:ext>
            </a:extLst>
          </p:cNvPr>
          <p:cNvSpPr txBox="1"/>
          <p:nvPr/>
        </p:nvSpPr>
        <p:spPr>
          <a:xfrm>
            <a:off x="5500441" y="1"/>
            <a:ext cx="1109599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62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9497DCB-7EAB-2F7B-CAE3-05DE1CC27A94}"/>
              </a:ext>
            </a:extLst>
          </p:cNvPr>
          <p:cNvSpPr txBox="1"/>
          <p:nvPr/>
        </p:nvSpPr>
        <p:spPr>
          <a:xfrm>
            <a:off x="263770" y="5942214"/>
            <a:ext cx="6160679" cy="9448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8" dirty="0">
                <a:latin typeface="Arial" panose="020B0604020202020204" pitchFamily="34" charset="0"/>
                <a:cs typeface="Arial" panose="020B0604020202020204" pitchFamily="34" charset="0"/>
              </a:rPr>
              <a:t>Figure S3. Toxicity of free romidepsin and Nanoromidepsin in mice: BALB/c mice were administered a single treatment of indicated doses of romidepsin and Nanoromidepsin by (upper panel) intraperitoneal; (lower panel) intravenous route of administration. Tolerability of various doses of free </a:t>
            </a:r>
            <a:r>
              <a:rPr lang="en-US" sz="1108" dirty="0" err="1">
                <a:latin typeface="Arial" panose="020B0604020202020204" pitchFamily="34" charset="0"/>
                <a:cs typeface="Arial" panose="020B0604020202020204" pitchFamily="34" charset="0"/>
              </a:rPr>
              <a:t>romidepsin</a:t>
            </a:r>
            <a:r>
              <a:rPr lang="en-US" sz="1108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108" dirty="0" err="1">
                <a:latin typeface="Arial" panose="020B0604020202020204" pitchFamily="34" charset="0"/>
                <a:cs typeface="Arial" panose="020B0604020202020204" pitchFamily="34" charset="0"/>
              </a:rPr>
              <a:t>Nanoromidepsin</a:t>
            </a:r>
            <a:r>
              <a:rPr lang="en-US" sz="1108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en-US" sz="1108" dirty="0" err="1">
                <a:latin typeface="Arial" panose="020B0604020202020204" pitchFamily="34" charset="0"/>
                <a:cs typeface="Arial" panose="020B0604020202020204" pitchFamily="34" charset="0"/>
              </a:rPr>
              <a:t>balb</a:t>
            </a:r>
            <a:r>
              <a:rPr lang="en-US" sz="1108" dirty="0">
                <a:latin typeface="Arial" panose="020B0604020202020204" pitchFamily="34" charset="0"/>
                <a:cs typeface="Arial" panose="020B0604020202020204" pitchFamily="34" charset="0"/>
              </a:rPr>
              <a:t>/c mice was assessed by monitoring clinical score after a single treatment. </a:t>
            </a:r>
          </a:p>
        </p:txBody>
      </p:sp>
    </p:spTree>
    <p:extLst>
      <p:ext uri="{BB962C8B-B14F-4D97-AF65-F5344CB8AC3E}">
        <p14:creationId xmlns:p14="http://schemas.microsoft.com/office/powerpoint/2010/main" val="34716749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BF85886-F141-1E60-CF11-26B3DC9E1D0D}"/>
              </a:ext>
            </a:extLst>
          </p:cNvPr>
          <p:cNvSpPr txBox="1"/>
          <p:nvPr/>
        </p:nvSpPr>
        <p:spPr>
          <a:xfrm>
            <a:off x="276161" y="5606054"/>
            <a:ext cx="6318070" cy="77431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8" dirty="0">
                <a:latin typeface="Arial" panose="020B0604020202020204" pitchFamily="34" charset="0"/>
                <a:cs typeface="Arial" panose="020B0604020202020204" pitchFamily="34" charset="0"/>
              </a:rPr>
              <a:t>Figure S4. Mice were administered a treatment of romidepsin or Nanoromidepsin or ghost PNP by intraperitoneal route of administration for 1, 8 and 15 days in H9-dTmato-luc xenograft bearing NSG mice. Depicted are the percentage of body weight changes as a percentage of starting weights with SEM and clinical score. X represents dead mice.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70281B85-125C-89E4-9569-5500A5CF771F}"/>
              </a:ext>
            </a:extLst>
          </p:cNvPr>
          <p:cNvGrpSpPr/>
          <p:nvPr/>
        </p:nvGrpSpPr>
        <p:grpSpPr>
          <a:xfrm>
            <a:off x="341435" y="622789"/>
            <a:ext cx="6176596" cy="4586654"/>
            <a:chOff x="1084308" y="603932"/>
            <a:chExt cx="8666542" cy="6255036"/>
          </a:xfrm>
        </p:grpSpPr>
        <p:graphicFrame>
          <p:nvGraphicFramePr>
            <p:cNvPr id="9" name="Object 8">
              <a:extLst>
                <a:ext uri="{FF2B5EF4-FFF2-40B4-BE49-F238E27FC236}">
                  <a16:creationId xmlns:a16="http://schemas.microsoft.com/office/drawing/2014/main" id="{4332C150-0B1C-613F-9485-AF10A917D88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55466622"/>
                </p:ext>
              </p:extLst>
            </p:nvPr>
          </p:nvGraphicFramePr>
          <p:xfrm>
            <a:off x="1084308" y="603932"/>
            <a:ext cx="8666542" cy="625503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75" name="Prism 10" r:id="rId3" imgW="8103054" imgH="6066435" progId="Prism10.Document">
                    <p:embed/>
                  </p:oleObj>
                </mc:Choice>
                <mc:Fallback>
                  <p:oleObj name="Prism 10" r:id="rId3" imgW="8103054" imgH="6066435" progId="Prism10.Document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695DD16A-C386-70E6-1043-5F669FE66B6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084308" y="603932"/>
                          <a:ext cx="8666542" cy="625503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7901B99-63C9-6D09-065A-CD50E344814E}"/>
                </a:ext>
              </a:extLst>
            </p:cNvPr>
            <p:cNvSpPr txBox="1"/>
            <p:nvPr/>
          </p:nvSpPr>
          <p:spPr>
            <a:xfrm>
              <a:off x="7224791" y="4281335"/>
              <a:ext cx="690960" cy="3196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23" dirty="0" err="1">
                  <a:solidFill>
                    <a:srgbClr val="FF0000"/>
                  </a:solidFill>
                </a:rPr>
                <a:t>xxxxxx</a:t>
              </a:r>
              <a:endParaRPr lang="en-US" sz="923" dirty="0">
                <a:solidFill>
                  <a:srgbClr val="FF0000"/>
                </a:solidFill>
              </a:endParaRP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0C6772AD-C4E6-4DDD-BDB0-F4F9E612309F}"/>
              </a:ext>
            </a:extLst>
          </p:cNvPr>
          <p:cNvSpPr txBox="1"/>
          <p:nvPr/>
        </p:nvSpPr>
        <p:spPr>
          <a:xfrm>
            <a:off x="5500441" y="1"/>
            <a:ext cx="1109599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62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</p:spTree>
    <p:extLst>
      <p:ext uri="{BB962C8B-B14F-4D97-AF65-F5344CB8AC3E}">
        <p14:creationId xmlns:p14="http://schemas.microsoft.com/office/powerpoint/2010/main" val="30228166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EB99B885-DC91-39A5-B280-4D5D94BD497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10916425"/>
              </p:ext>
            </p:extLst>
          </p:nvPr>
        </p:nvGraphicFramePr>
        <p:xfrm>
          <a:off x="249115" y="2165843"/>
          <a:ext cx="4271435" cy="2128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2" name="Prism 10" r:id="rId4" imgW="7802700" imgH="3889303" progId="Prism10.Document">
                  <p:embed/>
                </p:oleObj>
              </mc:Choice>
              <mc:Fallback>
                <p:oleObj name="Prism 10" r:id="rId4" imgW="7802700" imgH="3889303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EB99B885-DC91-39A5-B280-4D5D94BD497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49115" y="2165843"/>
                        <a:ext cx="4271435" cy="2128950"/>
                      </a:xfrm>
                      <a:prstGeom prst="rect">
                        <a:avLst/>
                      </a:prstGeom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41" name="TextBox 40">
            <a:extLst>
              <a:ext uri="{FF2B5EF4-FFF2-40B4-BE49-F238E27FC236}">
                <a16:creationId xmlns:a16="http://schemas.microsoft.com/office/drawing/2014/main" id="{62DF7408-5870-423D-8ADB-9076D1EB35B1}"/>
              </a:ext>
            </a:extLst>
          </p:cNvPr>
          <p:cNvSpPr txBox="1"/>
          <p:nvPr/>
        </p:nvSpPr>
        <p:spPr>
          <a:xfrm>
            <a:off x="4053120" y="7858528"/>
            <a:ext cx="239168" cy="23621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935" b="1" dirty="0">
                <a:solidFill>
                  <a:srgbClr val="FF0000"/>
                </a:solidFill>
              </a:rPr>
              <a:t>x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076012E9-C411-4476-90F4-544791311F72}"/>
              </a:ext>
            </a:extLst>
          </p:cNvPr>
          <p:cNvSpPr txBox="1"/>
          <p:nvPr/>
        </p:nvSpPr>
        <p:spPr>
          <a:xfrm>
            <a:off x="4238391" y="7858528"/>
            <a:ext cx="792205" cy="2362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35" dirty="0"/>
              <a:t>Dead mouse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98207F22-4E9B-4F94-BCBC-113FA1CBA34B}"/>
              </a:ext>
            </a:extLst>
          </p:cNvPr>
          <p:cNvSpPr txBox="1"/>
          <p:nvPr/>
        </p:nvSpPr>
        <p:spPr>
          <a:xfrm>
            <a:off x="5500441" y="1"/>
            <a:ext cx="1109599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62" dirty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CADDEF6C-1295-4496-8589-A72751EA0F4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51336500"/>
              </p:ext>
            </p:extLst>
          </p:nvPr>
        </p:nvGraphicFramePr>
        <p:xfrm>
          <a:off x="524608" y="331177"/>
          <a:ext cx="4236427" cy="19416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3" name="Prism 10" r:id="rId6" imgW="8862220" imgH="4063258" progId="Prism10.Document">
                  <p:embed/>
                </p:oleObj>
              </mc:Choice>
              <mc:Fallback>
                <p:oleObj name="Prism 10" r:id="rId6" imgW="8862220" imgH="4063258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CADDEF6C-1295-4496-8589-A72751EA0F4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24608" y="331177"/>
                        <a:ext cx="4236427" cy="19416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5" name="Group 4">
            <a:extLst>
              <a:ext uri="{FF2B5EF4-FFF2-40B4-BE49-F238E27FC236}">
                <a16:creationId xmlns:a16="http://schemas.microsoft.com/office/drawing/2014/main" id="{6AD2A6CD-578F-41BF-BD7B-6F98535E89D8}"/>
              </a:ext>
            </a:extLst>
          </p:cNvPr>
          <p:cNvGrpSpPr/>
          <p:nvPr/>
        </p:nvGrpSpPr>
        <p:grpSpPr>
          <a:xfrm>
            <a:off x="495138" y="4116996"/>
            <a:ext cx="4040066" cy="2247900"/>
            <a:chOff x="2956284" y="4917742"/>
            <a:chExt cx="3720440" cy="2038544"/>
          </a:xfrm>
        </p:grpSpPr>
        <p:graphicFrame>
          <p:nvGraphicFramePr>
            <p:cNvPr id="6" name="Object 5">
              <a:extLst>
                <a:ext uri="{FF2B5EF4-FFF2-40B4-BE49-F238E27FC236}">
                  <a16:creationId xmlns:a16="http://schemas.microsoft.com/office/drawing/2014/main" id="{88C6F1B2-40E7-422B-85B9-491FD714497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43109786"/>
                </p:ext>
              </p:extLst>
            </p:nvPr>
          </p:nvGraphicFramePr>
          <p:xfrm>
            <a:off x="2956284" y="4917742"/>
            <a:ext cx="3720440" cy="203854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104" name="Prism 10" r:id="rId8" imgW="8604723" imgH="4714056" progId="Prism10.Document">
                    <p:embed/>
                  </p:oleObj>
                </mc:Choice>
                <mc:Fallback>
                  <p:oleObj name="Prism 10" r:id="rId8" imgW="8604723" imgH="4714056" progId="Prism10.Document">
                    <p:embed/>
                    <p:pic>
                      <p:nvPicPr>
                        <p:cNvPr id="6" name="Object 5">
                          <a:extLst>
                            <a:ext uri="{FF2B5EF4-FFF2-40B4-BE49-F238E27FC236}">
                              <a16:creationId xmlns:a16="http://schemas.microsoft.com/office/drawing/2014/main" id="{88C6F1B2-40E7-422B-85B9-491FD714497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2956284" y="4917742"/>
                          <a:ext cx="3720440" cy="203854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23A75D8E-F777-4EF4-A70C-1BA9FA16E4A9}"/>
                </a:ext>
              </a:extLst>
            </p:cNvPr>
            <p:cNvSpPr txBox="1"/>
            <p:nvPr/>
          </p:nvSpPr>
          <p:spPr>
            <a:xfrm>
              <a:off x="4939754" y="5427963"/>
              <a:ext cx="220246" cy="214219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935" b="1" dirty="0">
                  <a:solidFill>
                    <a:srgbClr val="FF0000"/>
                  </a:solidFill>
                </a:rPr>
                <a:t>x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1ED01580-66E5-42B6-A000-B0006BEEA8E0}"/>
                </a:ext>
              </a:extLst>
            </p:cNvPr>
            <p:cNvSpPr txBox="1"/>
            <p:nvPr/>
          </p:nvSpPr>
          <p:spPr>
            <a:xfrm>
              <a:off x="6142082" y="5412378"/>
              <a:ext cx="220246" cy="214219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935" b="1" dirty="0">
                  <a:solidFill>
                    <a:srgbClr val="FF0000"/>
                  </a:solidFill>
                </a:rPr>
                <a:t>x</a:t>
              </a:r>
            </a:p>
          </p:txBody>
        </p:sp>
      </p:grp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314710FA-2C4F-1267-69E6-6728473753D9}"/>
              </a:ext>
            </a:extLst>
          </p:cNvPr>
          <p:cNvCxnSpPr/>
          <p:nvPr/>
        </p:nvCxnSpPr>
        <p:spPr>
          <a:xfrm>
            <a:off x="1744603" y="647841"/>
            <a:ext cx="0" cy="1181686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38485DDD-DB9A-D918-4355-7334BDBB7D60}"/>
              </a:ext>
            </a:extLst>
          </p:cNvPr>
          <p:cNvCxnSpPr/>
          <p:nvPr/>
        </p:nvCxnSpPr>
        <p:spPr>
          <a:xfrm>
            <a:off x="3081618" y="647841"/>
            <a:ext cx="0" cy="1181686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E81D8048-DB30-A365-C294-CD8E3B10F37E}"/>
              </a:ext>
            </a:extLst>
          </p:cNvPr>
          <p:cNvCxnSpPr>
            <a:cxnSpLocks/>
          </p:cNvCxnSpPr>
          <p:nvPr/>
        </p:nvCxnSpPr>
        <p:spPr>
          <a:xfrm>
            <a:off x="1905712" y="4761877"/>
            <a:ext cx="0" cy="1181686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F513F567-7336-491C-4EAB-25F4143BF19B}"/>
              </a:ext>
            </a:extLst>
          </p:cNvPr>
          <p:cNvCxnSpPr>
            <a:cxnSpLocks/>
          </p:cNvCxnSpPr>
          <p:nvPr/>
        </p:nvCxnSpPr>
        <p:spPr>
          <a:xfrm>
            <a:off x="3064402" y="4738100"/>
            <a:ext cx="0" cy="1181686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77159E66-E453-D079-45FE-718B6100002A}"/>
              </a:ext>
            </a:extLst>
          </p:cNvPr>
          <p:cNvCxnSpPr/>
          <p:nvPr/>
        </p:nvCxnSpPr>
        <p:spPr>
          <a:xfrm>
            <a:off x="1771904" y="2732290"/>
            <a:ext cx="0" cy="1181686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B05AAEDC-17AD-4141-C241-2F1AE524BAE2}"/>
              </a:ext>
            </a:extLst>
          </p:cNvPr>
          <p:cNvCxnSpPr/>
          <p:nvPr/>
        </p:nvCxnSpPr>
        <p:spPr>
          <a:xfrm>
            <a:off x="2872662" y="2732290"/>
            <a:ext cx="0" cy="1181686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2" name="Group 1">
            <a:extLst>
              <a:ext uri="{FF2B5EF4-FFF2-40B4-BE49-F238E27FC236}">
                <a16:creationId xmlns:a16="http://schemas.microsoft.com/office/drawing/2014/main" id="{5FF9F069-FB0E-95E9-11AF-FFCF129AFCAF}"/>
              </a:ext>
            </a:extLst>
          </p:cNvPr>
          <p:cNvGrpSpPr/>
          <p:nvPr/>
        </p:nvGrpSpPr>
        <p:grpSpPr>
          <a:xfrm>
            <a:off x="263769" y="6357022"/>
            <a:ext cx="4051495" cy="1941342"/>
            <a:chOff x="-42509" y="7131476"/>
            <a:chExt cx="3740150" cy="1801813"/>
          </a:xfrm>
        </p:grpSpPr>
        <p:graphicFrame>
          <p:nvGraphicFramePr>
            <p:cNvPr id="34" name="Object 33">
              <a:extLst>
                <a:ext uri="{FF2B5EF4-FFF2-40B4-BE49-F238E27FC236}">
                  <a16:creationId xmlns:a16="http://schemas.microsoft.com/office/drawing/2014/main" id="{AA4936F4-1E6E-4231-8F57-A83A4908F1F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081372183"/>
                </p:ext>
              </p:extLst>
            </p:nvPr>
          </p:nvGraphicFramePr>
          <p:xfrm>
            <a:off x="-42509" y="7131476"/>
            <a:ext cx="3740150" cy="18018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105" name="Prism 10" r:id="rId10" imgW="8343984" imgH="4026522" progId="Prism10.Document">
                    <p:embed/>
                  </p:oleObj>
                </mc:Choice>
                <mc:Fallback>
                  <p:oleObj name="Prism 10" r:id="rId10" imgW="8343984" imgH="4026522" progId="Prism10.Document">
                    <p:embed/>
                    <p:pic>
                      <p:nvPicPr>
                        <p:cNvPr id="14" name="Object 13">
                          <a:extLst>
                            <a:ext uri="{FF2B5EF4-FFF2-40B4-BE49-F238E27FC236}">
                              <a16:creationId xmlns:a16="http://schemas.microsoft.com/office/drawing/2014/main" id="{30A5B37F-153B-B914-647D-9CDC3257A63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-42509" y="7131476"/>
                          <a:ext cx="3740150" cy="1801813"/>
                        </a:xfrm>
                        <a:prstGeom prst="rect">
                          <a:avLst/>
                        </a:prstGeom>
                        <a:ln>
                          <a:noFill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CA5E16CC-0A61-4250-B6BC-5C6F3BD50A6A}"/>
                </a:ext>
              </a:extLst>
            </p:cNvPr>
            <p:cNvSpPr txBox="1"/>
            <p:nvPr/>
          </p:nvSpPr>
          <p:spPr>
            <a:xfrm>
              <a:off x="1562626" y="7478021"/>
              <a:ext cx="220789" cy="219241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935" b="1" dirty="0">
                  <a:solidFill>
                    <a:srgbClr val="FF0000"/>
                  </a:solidFill>
                </a:rPr>
                <a:t>x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CB393B30-7142-4699-AE00-2103DC6C6D42}"/>
                </a:ext>
              </a:extLst>
            </p:cNvPr>
            <p:cNvSpPr txBox="1"/>
            <p:nvPr/>
          </p:nvSpPr>
          <p:spPr>
            <a:xfrm>
              <a:off x="2764953" y="7462435"/>
              <a:ext cx="220789" cy="219241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935" b="1" dirty="0">
                  <a:solidFill>
                    <a:srgbClr val="FF0000"/>
                  </a:solidFill>
                </a:rPr>
                <a:t>x</a:t>
              </a:r>
            </a:p>
          </p:txBody>
        </p: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0A22A773-1A73-B284-D8D8-0B700ACFFB90}"/>
                </a:ext>
              </a:extLst>
            </p:cNvPr>
            <p:cNvCxnSpPr/>
            <p:nvPr/>
          </p:nvCxnSpPr>
          <p:spPr>
            <a:xfrm>
              <a:off x="1283254" y="7359200"/>
              <a:ext cx="0" cy="1280160"/>
            </a:xfrm>
            <a:prstGeom prst="line">
              <a:avLst/>
            </a:prstGeom>
            <a:ln w="12700">
              <a:prstDash val="sys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DE3AA01B-EF3A-571F-FDC5-F81A465C7F4D}"/>
                </a:ext>
              </a:extLst>
            </p:cNvPr>
            <p:cNvCxnSpPr/>
            <p:nvPr/>
          </p:nvCxnSpPr>
          <p:spPr>
            <a:xfrm>
              <a:off x="2286995" y="7370234"/>
              <a:ext cx="0" cy="1280160"/>
            </a:xfrm>
            <a:prstGeom prst="line">
              <a:avLst/>
            </a:prstGeom>
            <a:ln w="12700">
              <a:prstDash val="sysDas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5" name="TextBox 24">
            <a:extLst>
              <a:ext uri="{FF2B5EF4-FFF2-40B4-BE49-F238E27FC236}">
                <a16:creationId xmlns:a16="http://schemas.microsoft.com/office/drawing/2014/main" id="{8D9F4B81-1ED8-FFE2-F9A0-B7C1D4462425}"/>
              </a:ext>
            </a:extLst>
          </p:cNvPr>
          <p:cNvSpPr txBox="1"/>
          <p:nvPr/>
        </p:nvSpPr>
        <p:spPr>
          <a:xfrm>
            <a:off x="263769" y="8298364"/>
            <a:ext cx="6318070" cy="77431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8" dirty="0">
                <a:latin typeface="Arial" panose="020B0604020202020204" pitchFamily="34" charset="0"/>
                <a:cs typeface="Arial" panose="020B0604020202020204" pitchFamily="34" charset="0"/>
              </a:rPr>
              <a:t>Figure S5. Mice were administered a 2 and 3 mg/kg treatment of romidepsin or Nanoromidepsin or ghost PNP by intravenous route of administration for arrow indicated days (1, 4, 8 and 11 days) in H9-dTmato-luc xenograft bearing NSG mice. Depicted are the percentage of body weight changes as a percentage of starting weights with SEM and clinical score. X represents dead mice.</a:t>
            </a:r>
          </a:p>
        </p:txBody>
      </p:sp>
    </p:spTree>
    <p:extLst>
      <p:ext uri="{BB962C8B-B14F-4D97-AF65-F5344CB8AC3E}">
        <p14:creationId xmlns:p14="http://schemas.microsoft.com/office/powerpoint/2010/main" val="383729813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5AD49678-C244-4CEB-B0D4-D44372C808FD}"/>
              </a:ext>
            </a:extLst>
          </p:cNvPr>
          <p:cNvSpPr txBox="1"/>
          <p:nvPr/>
        </p:nvSpPr>
        <p:spPr>
          <a:xfrm>
            <a:off x="5500441" y="1"/>
            <a:ext cx="1109599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62" dirty="0"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</a:p>
        </p:txBody>
      </p:sp>
      <p:graphicFrame>
        <p:nvGraphicFramePr>
          <p:cNvPr id="43" name="Object 42">
            <a:extLst>
              <a:ext uri="{FF2B5EF4-FFF2-40B4-BE49-F238E27FC236}">
                <a16:creationId xmlns:a16="http://schemas.microsoft.com/office/drawing/2014/main" id="{512C6744-1176-4B3A-85FC-6AADE24CC31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48012072"/>
              </p:ext>
            </p:extLst>
          </p:nvPr>
        </p:nvGraphicFramePr>
        <p:xfrm>
          <a:off x="270524" y="2111233"/>
          <a:ext cx="4557932" cy="2179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6" name="Prism 10" r:id="rId3" imgW="9220555" imgH="4410807" progId="Prism10.Document">
                  <p:embed/>
                </p:oleObj>
              </mc:Choice>
              <mc:Fallback>
                <p:oleObj name="Prism 10" r:id="rId3" imgW="9220555" imgH="4410807" progId="Prism10.Document">
                  <p:embed/>
                  <p:pic>
                    <p:nvPicPr>
                      <p:cNvPr id="43" name="Object 42">
                        <a:extLst>
                          <a:ext uri="{FF2B5EF4-FFF2-40B4-BE49-F238E27FC236}">
                            <a16:creationId xmlns:a16="http://schemas.microsoft.com/office/drawing/2014/main" id="{512C6744-1176-4B3A-85FC-6AADE24CC31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70524" y="2111233"/>
                        <a:ext cx="4557932" cy="2179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" name="Group 1">
            <a:extLst>
              <a:ext uri="{FF2B5EF4-FFF2-40B4-BE49-F238E27FC236}">
                <a16:creationId xmlns:a16="http://schemas.microsoft.com/office/drawing/2014/main" id="{03111805-05BD-40AE-B0FC-D571B4820046}"/>
              </a:ext>
            </a:extLst>
          </p:cNvPr>
          <p:cNvGrpSpPr/>
          <p:nvPr/>
        </p:nvGrpSpPr>
        <p:grpSpPr>
          <a:xfrm>
            <a:off x="312775" y="6219057"/>
            <a:ext cx="4557932" cy="1659978"/>
            <a:chOff x="236174" y="5656924"/>
            <a:chExt cx="3979863" cy="1617662"/>
          </a:xfrm>
        </p:grpSpPr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2600E709-4328-40FD-9BE3-B628354F880C}"/>
                </a:ext>
              </a:extLst>
            </p:cNvPr>
            <p:cNvSpPr txBox="1"/>
            <p:nvPr/>
          </p:nvSpPr>
          <p:spPr>
            <a:xfrm>
              <a:off x="1609903" y="5794987"/>
              <a:ext cx="207436" cy="1833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23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51485061-6BAE-485F-B56D-7C4EC16CD1F3}"/>
                </a:ext>
              </a:extLst>
            </p:cNvPr>
            <p:cNvSpPr txBox="1"/>
            <p:nvPr/>
          </p:nvSpPr>
          <p:spPr>
            <a:xfrm>
              <a:off x="1695048" y="5794987"/>
              <a:ext cx="207436" cy="1833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23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</a:p>
          </p:txBody>
        </p:sp>
        <p:graphicFrame>
          <p:nvGraphicFramePr>
            <p:cNvPr id="48" name="Object 47">
              <a:extLst>
                <a:ext uri="{FF2B5EF4-FFF2-40B4-BE49-F238E27FC236}">
                  <a16:creationId xmlns:a16="http://schemas.microsoft.com/office/drawing/2014/main" id="{2F500A72-1448-45B5-A639-1B98EECAD34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63126564"/>
                </p:ext>
              </p:extLst>
            </p:nvPr>
          </p:nvGraphicFramePr>
          <p:xfrm>
            <a:off x="236174" y="5656924"/>
            <a:ext cx="3979863" cy="16176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127" name="Prism 10" r:id="rId5" imgW="8918761" imgH="3825196" progId="Prism10.Document">
                    <p:embed/>
                  </p:oleObj>
                </mc:Choice>
                <mc:Fallback>
                  <p:oleObj name="Prism 10" r:id="rId5" imgW="8918761" imgH="3825196" progId="Prism10.Document">
                    <p:embed/>
                    <p:pic>
                      <p:nvPicPr>
                        <p:cNvPr id="48" name="Object 47">
                          <a:extLst>
                            <a:ext uri="{FF2B5EF4-FFF2-40B4-BE49-F238E27FC236}">
                              <a16:creationId xmlns:a16="http://schemas.microsoft.com/office/drawing/2014/main" id="{2F500A72-1448-45B5-A639-1B98EECAD34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236174" y="5656924"/>
                          <a:ext cx="3979863" cy="161766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F8C8A517-E13B-425C-8348-489545E57E8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42257791"/>
              </p:ext>
            </p:extLst>
          </p:nvPr>
        </p:nvGraphicFramePr>
        <p:xfrm>
          <a:off x="321979" y="556264"/>
          <a:ext cx="4557932" cy="16477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8" name="Prism 10" r:id="rId7" imgW="10045265" imgH="3633234" progId="Prism10.Document">
                  <p:embed/>
                </p:oleObj>
              </mc:Choice>
              <mc:Fallback>
                <p:oleObj name="Prism 10" r:id="rId7" imgW="10045265" imgH="3633234" progId="Prism10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F8C8A517-E13B-425C-8348-489545E57E8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21979" y="556264"/>
                        <a:ext cx="4557932" cy="16477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5" name="Group 14">
            <a:extLst>
              <a:ext uri="{FF2B5EF4-FFF2-40B4-BE49-F238E27FC236}">
                <a16:creationId xmlns:a16="http://schemas.microsoft.com/office/drawing/2014/main" id="{9634FCE6-5604-189E-ECE7-EC42AF50EC2D}"/>
              </a:ext>
            </a:extLst>
          </p:cNvPr>
          <p:cNvGrpSpPr/>
          <p:nvPr/>
        </p:nvGrpSpPr>
        <p:grpSpPr>
          <a:xfrm>
            <a:off x="321979" y="4195099"/>
            <a:ext cx="4557932" cy="1901394"/>
            <a:chOff x="124119" y="594024"/>
            <a:chExt cx="4154487" cy="1547813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626E851-2D2F-4E64-9CCB-5F1906E5DB85}"/>
                </a:ext>
              </a:extLst>
            </p:cNvPr>
            <p:cNvSpPr txBox="1"/>
            <p:nvPr/>
          </p:nvSpPr>
          <p:spPr>
            <a:xfrm>
              <a:off x="1420456" y="873700"/>
              <a:ext cx="216538" cy="1531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23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EDD44282-4562-4241-8BDB-705F74709965}"/>
                </a:ext>
              </a:extLst>
            </p:cNvPr>
            <p:cNvSpPr txBox="1"/>
            <p:nvPr/>
          </p:nvSpPr>
          <p:spPr>
            <a:xfrm>
              <a:off x="1504435" y="873700"/>
              <a:ext cx="216538" cy="1531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23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</a:p>
          </p:txBody>
        </p:sp>
        <p:graphicFrame>
          <p:nvGraphicFramePr>
            <p:cNvPr id="14" name="Object 13">
              <a:extLst>
                <a:ext uri="{FF2B5EF4-FFF2-40B4-BE49-F238E27FC236}">
                  <a16:creationId xmlns:a16="http://schemas.microsoft.com/office/drawing/2014/main" id="{938B6077-783B-4624-9F13-29A5A5EE304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41078033"/>
                </p:ext>
              </p:extLst>
            </p:nvPr>
          </p:nvGraphicFramePr>
          <p:xfrm>
            <a:off x="124119" y="594024"/>
            <a:ext cx="4154487" cy="15478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129" name="Prism 9" r:id="rId9" imgW="10210208" imgH="4255220" progId="Prism9.Document">
                    <p:embed/>
                  </p:oleObj>
                </mc:Choice>
                <mc:Fallback>
                  <p:oleObj name="Prism 9" r:id="rId9" imgW="10210208" imgH="4255220" progId="Prism9.Document">
                    <p:embed/>
                    <p:pic>
                      <p:nvPicPr>
                        <p:cNvPr id="12" name="Object 11">
                          <a:extLst>
                            <a:ext uri="{FF2B5EF4-FFF2-40B4-BE49-F238E27FC236}">
                              <a16:creationId xmlns:a16="http://schemas.microsoft.com/office/drawing/2014/main" id="{938B6077-783B-4624-9F13-29A5A5EE304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124119" y="594024"/>
                          <a:ext cx="4154487" cy="15478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80610BBD-A687-4B68-82E7-D557042CB9CD}"/>
              </a:ext>
            </a:extLst>
          </p:cNvPr>
          <p:cNvSpPr txBox="1"/>
          <p:nvPr/>
        </p:nvSpPr>
        <p:spPr>
          <a:xfrm>
            <a:off x="4652988" y="7371758"/>
            <a:ext cx="239168" cy="23621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935" b="1" dirty="0">
                <a:solidFill>
                  <a:srgbClr val="FF0000"/>
                </a:solidFill>
              </a:rPr>
              <a:t>x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261A0D9-A054-8BFD-8391-C67571449DB7}"/>
              </a:ext>
            </a:extLst>
          </p:cNvPr>
          <p:cNvSpPr txBox="1"/>
          <p:nvPr/>
        </p:nvSpPr>
        <p:spPr>
          <a:xfrm>
            <a:off x="4790706" y="7366153"/>
            <a:ext cx="792205" cy="2362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35" dirty="0"/>
              <a:t>Dead mouse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E0641B53-0982-B199-73E9-E2C644C364D4}"/>
              </a:ext>
            </a:extLst>
          </p:cNvPr>
          <p:cNvCxnSpPr>
            <a:cxnSpLocks/>
          </p:cNvCxnSpPr>
          <p:nvPr/>
        </p:nvCxnSpPr>
        <p:spPr>
          <a:xfrm>
            <a:off x="1744204" y="659730"/>
            <a:ext cx="0" cy="1181686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35D039FD-7054-1D61-33C3-95EF56A727BA}"/>
              </a:ext>
            </a:extLst>
          </p:cNvPr>
          <p:cNvCxnSpPr>
            <a:cxnSpLocks/>
          </p:cNvCxnSpPr>
          <p:nvPr/>
        </p:nvCxnSpPr>
        <p:spPr>
          <a:xfrm>
            <a:off x="2971494" y="659730"/>
            <a:ext cx="0" cy="1181686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CFEFBA94-CB62-4B7F-A653-8FFB11A78153}"/>
              </a:ext>
            </a:extLst>
          </p:cNvPr>
          <p:cNvCxnSpPr>
            <a:cxnSpLocks/>
          </p:cNvCxnSpPr>
          <p:nvPr/>
        </p:nvCxnSpPr>
        <p:spPr>
          <a:xfrm>
            <a:off x="1826670" y="2731075"/>
            <a:ext cx="0" cy="1181686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13F2D785-F5E2-C498-094B-F7367682630B}"/>
              </a:ext>
            </a:extLst>
          </p:cNvPr>
          <p:cNvCxnSpPr>
            <a:cxnSpLocks/>
          </p:cNvCxnSpPr>
          <p:nvPr/>
        </p:nvCxnSpPr>
        <p:spPr>
          <a:xfrm>
            <a:off x="2986050" y="2731075"/>
            <a:ext cx="0" cy="1181686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C9CCCD87-4EAD-4A3A-AF27-F311015630F1}"/>
              </a:ext>
            </a:extLst>
          </p:cNvPr>
          <p:cNvCxnSpPr>
            <a:cxnSpLocks/>
          </p:cNvCxnSpPr>
          <p:nvPr/>
        </p:nvCxnSpPr>
        <p:spPr>
          <a:xfrm>
            <a:off x="1744204" y="4572000"/>
            <a:ext cx="0" cy="1181686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4482F579-E9DD-18E5-E6F4-0A73B03D26F1}"/>
              </a:ext>
            </a:extLst>
          </p:cNvPr>
          <p:cNvCxnSpPr>
            <a:cxnSpLocks/>
          </p:cNvCxnSpPr>
          <p:nvPr/>
        </p:nvCxnSpPr>
        <p:spPr>
          <a:xfrm>
            <a:off x="2903584" y="4572000"/>
            <a:ext cx="0" cy="1181686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61B58D72-3F57-B63E-3360-D6A075FC2327}"/>
              </a:ext>
            </a:extLst>
          </p:cNvPr>
          <p:cNvCxnSpPr>
            <a:cxnSpLocks/>
          </p:cNvCxnSpPr>
          <p:nvPr/>
        </p:nvCxnSpPr>
        <p:spPr>
          <a:xfrm>
            <a:off x="1923689" y="6360732"/>
            <a:ext cx="0" cy="1181686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1229984B-CD6B-9477-049C-A376327CA82A}"/>
              </a:ext>
            </a:extLst>
          </p:cNvPr>
          <p:cNvCxnSpPr>
            <a:cxnSpLocks/>
          </p:cNvCxnSpPr>
          <p:nvPr/>
        </p:nvCxnSpPr>
        <p:spPr>
          <a:xfrm>
            <a:off x="3131576" y="6360732"/>
            <a:ext cx="0" cy="1181686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29929254-9855-C5B3-F9FF-CF352450F143}"/>
              </a:ext>
            </a:extLst>
          </p:cNvPr>
          <p:cNvSpPr txBox="1"/>
          <p:nvPr/>
        </p:nvSpPr>
        <p:spPr>
          <a:xfrm>
            <a:off x="321979" y="8087617"/>
            <a:ext cx="6318070" cy="77431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8" dirty="0">
                <a:latin typeface="Arial" panose="020B0604020202020204" pitchFamily="34" charset="0"/>
                <a:cs typeface="Arial" panose="020B0604020202020204" pitchFamily="34" charset="0"/>
              </a:rPr>
              <a:t>Figure S6. Mice were administered a 2.5 and 5 mg/kg treatment of romidepsin or Nanoromidepsin or ghost PNP by intravenous route of administration for arrow indicated days in H9-dTmato-luc xenograft bearing NSG mice. Depicted are the percentage of body weight changes as a percentage of starting weights with SEM and clinical score. X represents dead mice.</a:t>
            </a:r>
          </a:p>
        </p:txBody>
      </p:sp>
    </p:spTree>
    <p:extLst>
      <p:ext uri="{BB962C8B-B14F-4D97-AF65-F5344CB8AC3E}">
        <p14:creationId xmlns:p14="http://schemas.microsoft.com/office/powerpoint/2010/main" val="29954081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492</TotalTime>
  <Words>364</Words>
  <Application>Microsoft Office PowerPoint</Application>
  <PresentationFormat>Letter Paper (8.5x11 in)</PresentationFormat>
  <Paragraphs>27</Paragraphs>
  <Slides>6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6</vt:i4>
      </vt:variant>
    </vt:vector>
  </HeadingPairs>
  <TitlesOfParts>
    <vt:vector size="13" baseType="lpstr">
      <vt:lpstr>Aptos</vt:lpstr>
      <vt:lpstr>Arial</vt:lpstr>
      <vt:lpstr>Calibri</vt:lpstr>
      <vt:lpstr>Calibri Light</vt:lpstr>
      <vt:lpstr>Office Theme</vt:lpstr>
      <vt:lpstr>Prism 9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VA Health Syste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l, Ipsita *HS</dc:creator>
  <cp:lastModifiedBy>Pal, Ipsita *HS</cp:lastModifiedBy>
  <cp:revision>247</cp:revision>
  <dcterms:created xsi:type="dcterms:W3CDTF">2023-12-12T14:26:16Z</dcterms:created>
  <dcterms:modified xsi:type="dcterms:W3CDTF">2024-07-18T16:54:26Z</dcterms:modified>
</cp:coreProperties>
</file>